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7"/>
  </p:notesMasterIdLst>
  <p:sldIdLst>
    <p:sldId id="270" r:id="rId2"/>
    <p:sldId id="269" r:id="rId3"/>
    <p:sldId id="272" r:id="rId4"/>
    <p:sldId id="265" r:id="rId5"/>
    <p:sldId id="273" r:id="rId6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Pan, Ziwei" initials="PZ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974"/>
    <p:restoredTop sz="90185"/>
  </p:normalViewPr>
  <p:slideViewPr>
    <p:cSldViewPr snapToGrid="0" snapToObjects="1">
      <p:cViewPr>
        <p:scale>
          <a:sx n="103" d="100"/>
          <a:sy n="103" d="100"/>
        </p:scale>
        <p:origin x="3472" y="-1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72177DB-6F4D-2242-B301-2ED8D8D5D4F5}" type="datetimeFigureOut">
              <a:rPr lang="en-US" smtClean="0"/>
              <a:t>9/11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6EFBDCF-85FA-BA46-BB3D-79F6C4FD2FA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448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1. Additional performance of CNN models for primary </a:t>
            </a:r>
            <a:r>
              <a:rPr lang="en-US" sz="120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mour</a:t>
            </a: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ype prediction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200" b="0" i="0" u="none" kern="1200" dirty="0">
              <a:solidFill>
                <a:schemeClr val="tx1"/>
              </a:solidFill>
              <a:effectLst/>
              <a:latin typeface="+mn-lt"/>
              <a:ea typeface="+mn-ea"/>
              <a:cs typeface="Apple Chancery" panose="03020702040506060504" pitchFamily="66" charset="-79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6EFBDCF-85FA-BA46-BB3D-79F6C4FD2FA8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049029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. Performance metrics for primary site predictors, 1D-CNN and Reception on TCGA dataset.</a:t>
            </a:r>
            <a:r>
              <a:rPr lang="en-US" dirty="0">
                <a:effectLst/>
              </a:rPr>
              <a:t> </a:t>
            </a:r>
            <a:endParaRPr lang="en-US" sz="1200" b="0" u="none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6EFBDCF-85FA-BA46-BB3D-79F6C4FD2FA8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577213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3. Primary </a:t>
            </a:r>
            <a:r>
              <a:rPr lang="en-US" sz="1200" b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umour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 type prediction performance of CNN models</a:t>
            </a:r>
            <a:r>
              <a:rPr lang="en-US" b="0" dirty="0">
                <a:effectLst/>
              </a:rPr>
              <a:t> with a smaller feature size</a:t>
            </a:r>
            <a:endParaRPr lang="en-US" sz="1200" b="0" u="none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6EFBDCF-85FA-BA46-BB3D-79F6C4FD2FA8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47528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4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1D-Inception model performance with gene removal</a:t>
            </a:r>
            <a:endParaRPr lang="en-US" sz="1200" b="0" u="none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6EFBDCF-85FA-BA46-BB3D-79F6C4FD2FA8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16597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35581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41303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165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6318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93281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560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44296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787445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394256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8728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96847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54D823-9FCE-534C-947A-E1FBEED19448}" type="datetimeFigureOut">
              <a:rPr lang="en-US" smtClean="0"/>
              <a:t>9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CEA890-7329-204A-91D7-90A2596EE2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86895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B37AE76-B179-B940-B8A6-FDFC1832E6B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upplemental Figures</a:t>
            </a:r>
          </a:p>
        </p:txBody>
      </p:sp>
    </p:spTree>
    <p:extLst>
      <p:ext uri="{BB962C8B-B14F-4D97-AF65-F5344CB8AC3E}">
        <p14:creationId xmlns:p14="http://schemas.microsoft.com/office/powerpoint/2010/main" val="4167750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F93AC906-4B71-4E40-A887-9F47B5BF4831}"/>
              </a:ext>
            </a:extLst>
          </p:cNvPr>
          <p:cNvSpPr/>
          <p:nvPr/>
        </p:nvSpPr>
        <p:spPr>
          <a:xfrm>
            <a:off x="0" y="0"/>
            <a:ext cx="68580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Figure S1. Additional performance of CNN models for primary </a:t>
            </a:r>
            <a:r>
              <a:rPr lang="en-US" sz="1500" dirty="0" err="1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 types prediction on TCGA dataset </a:t>
            </a:r>
          </a:p>
        </p:txBody>
      </p:sp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:a16="http://schemas.microsoft.com/office/drawing/2014/main" id="{79D86FE3-C311-D342-9A0B-5575C02873D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53998"/>
            <a:ext cx="6858000" cy="77487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0957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03E16DF-F8A2-F245-9625-68C1D7F23309}"/>
              </a:ext>
            </a:extLst>
          </p:cNvPr>
          <p:cNvSpPr/>
          <p:nvPr/>
        </p:nvSpPr>
        <p:spPr>
          <a:xfrm>
            <a:off x="0" y="0"/>
            <a:ext cx="68580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Figure S2. Performance metrics for primary </a:t>
            </a:r>
            <a:r>
              <a:rPr lang="en-US" sz="1500" dirty="0" err="1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 type predictors, 1D-CNN and Reception on TCGA dataset. </a:t>
            </a:r>
          </a:p>
        </p:txBody>
      </p:sp>
      <p:pic>
        <p:nvPicPr>
          <p:cNvPr id="4" name="Picture 3" descr="A close up of a map&#10;&#10;Description automatically generated">
            <a:extLst>
              <a:ext uri="{FF2B5EF4-FFF2-40B4-BE49-F238E27FC236}">
                <a16:creationId xmlns:a16="http://schemas.microsoft.com/office/drawing/2014/main" id="{F582105A-24B1-2A4D-AAD0-38AE648D8CB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894" y="553998"/>
            <a:ext cx="6528211" cy="926610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446067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2C7BF40-D680-2B42-8909-2E7EC6932A4A}"/>
              </a:ext>
            </a:extLst>
          </p:cNvPr>
          <p:cNvSpPr/>
          <p:nvPr/>
        </p:nvSpPr>
        <p:spPr>
          <a:xfrm>
            <a:off x="0" y="0"/>
            <a:ext cx="6858000" cy="55399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Figure S3. Primary </a:t>
            </a:r>
            <a:r>
              <a:rPr lang="en-US" sz="1500" dirty="0" err="1">
                <a:latin typeface="Arial" panose="020B0604020202020204" pitchFamily="34" charset="0"/>
                <a:cs typeface="Arial" panose="020B0604020202020204" pitchFamily="34" charset="0"/>
              </a:rPr>
              <a:t>tumour</a:t>
            </a:r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 type prediction performance of CNN models with a smaller feature size on TCGA dataset</a:t>
            </a:r>
          </a:p>
        </p:txBody>
      </p:sp>
      <p:pic>
        <p:nvPicPr>
          <p:cNvPr id="4" name="Picture 3" descr="A screenshot of a social media post&#10;&#10;Description automatically generated">
            <a:extLst>
              <a:ext uri="{FF2B5EF4-FFF2-40B4-BE49-F238E27FC236}">
                <a16:creationId xmlns:a16="http://schemas.microsoft.com/office/drawing/2014/main" id="{2DECF597-F528-724C-A773-A6ED03D4EE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553998"/>
            <a:ext cx="6858000" cy="78206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114740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12C7BF40-D680-2B42-8909-2E7EC6932A4A}"/>
              </a:ext>
            </a:extLst>
          </p:cNvPr>
          <p:cNvSpPr/>
          <p:nvPr/>
        </p:nvSpPr>
        <p:spPr>
          <a:xfrm>
            <a:off x="0" y="0"/>
            <a:ext cx="6858000" cy="3231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defRPr/>
            </a:pPr>
            <a:r>
              <a:rPr lang="en-US" sz="1500" dirty="0">
                <a:latin typeface="Arial" panose="020B0604020202020204" pitchFamily="34" charset="0"/>
                <a:cs typeface="Arial" panose="020B0604020202020204" pitchFamily="34" charset="0"/>
              </a:rPr>
              <a:t>Figure S4. 1D-Inception model performance with gene removal</a:t>
            </a:r>
          </a:p>
        </p:txBody>
      </p:sp>
      <p:pic>
        <p:nvPicPr>
          <p:cNvPr id="9" name="Picture 8" descr="A screenshot of a cell phone&#10;&#10;Description automatically generated">
            <a:extLst>
              <a:ext uri="{FF2B5EF4-FFF2-40B4-BE49-F238E27FC236}">
                <a16:creationId xmlns:a16="http://schemas.microsoft.com/office/drawing/2014/main" id="{D1B3C1CC-FDDC-2749-8729-8D0415FA4D4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7782" y="323165"/>
            <a:ext cx="6522435" cy="89842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486214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75</TotalTime>
  <Words>123</Words>
  <Application>Microsoft Macintosh PowerPoint</Application>
  <PresentationFormat>A4 Paper (210x297 mm)</PresentationFormat>
  <Paragraphs>13</Paragraphs>
  <Slides>5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Supplemental Figures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, Ziwei</dc:creator>
  <cp:lastModifiedBy>Ziwei Pan</cp:lastModifiedBy>
  <cp:revision>106</cp:revision>
  <dcterms:created xsi:type="dcterms:W3CDTF">2019-10-14T18:47:33Z</dcterms:created>
  <dcterms:modified xsi:type="dcterms:W3CDTF">2020-09-11T13:44:04Z</dcterms:modified>
</cp:coreProperties>
</file>